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USNI JOHAN" initials="YJ" lastIdx="5" clrIdx="0">
    <p:extLst>
      <p:ext uri="{19B8F6BF-5375-455C-9EA6-DF929625EA0E}">
        <p15:presenceInfo xmlns:p15="http://schemas.microsoft.com/office/powerpoint/2012/main" userId="531c02f2f3bc3d1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4660"/>
  </p:normalViewPr>
  <p:slideViewPr>
    <p:cSldViewPr snapToGrid="0">
      <p:cViewPr varScale="1">
        <p:scale>
          <a:sx n="81" d="100"/>
          <a:sy n="81" d="100"/>
        </p:scale>
        <p:origin x="85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D4BD96-2882-B14B-AA8B-19074F42D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2A340B-99A7-DCF4-2A25-6C0D790716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2FCCC-2E49-79F6-8970-B907EAE1C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6F12E2-FC75-5764-8984-0ED315E8F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B98E7A-7427-6B85-AABA-D12FED83F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478133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3E751-0B48-27B0-48A8-7E0CA76A88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7EDC6-C0B3-1D54-9D7D-AC79E90CC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EF9FF-2965-CFAE-1938-937383351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E2D1D6-A832-DFDC-C311-94726FF3C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E360FF-1BFA-4034-F433-03AE7250A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482414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7CF712-3AD2-DECC-AF48-54BC1A0F0F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E7F76B-FEB6-8D57-95FA-CB041A32D8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D4C92A-7AD3-2EBA-4369-DED88BE6D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9F5DC-0472-E5C9-2CE1-C2C65AB1D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10C77-0D6C-0BBC-C05C-5223022FF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191129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4EECA-20EF-72D9-3B0D-6636045DC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1A027A-34B4-C366-AAF8-52AE8061E5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4D8070-56EF-7E5D-2635-5808F2E78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F33B1-6E4F-9835-5425-7EE585545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FED55-690E-1FFC-C2F5-79260C4F4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23413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B8C65-BC8C-FD00-4CCA-F72E444A56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18529D-C3AE-BBAB-BBC0-9CC34314C1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E3A15-9AD2-C61D-C6E5-284A6D24D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89FD2F-CF5E-E652-CF47-0F0C95A78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77E876-C696-B212-2758-091B346FD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926642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4051E-DBB1-ABA2-9A1D-BB5BCF89E0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A308C8-7E96-DACB-31DF-20D2C81C69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69DCC7-F687-F859-A891-12AFF3C12A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F6A532-5271-0014-6A71-46CA64A4D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CE19C4-9ACF-918A-6BD5-721DAC3CFF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FE85F5-3574-C9DB-2B79-10CF25F65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906949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ABA99A-6CCF-E922-C53A-EE4B91AF3F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42785E-81A4-6282-C084-80BBC5235A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A73E8F-97C2-7836-5AE3-BA54B654E3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1E0511-D203-F6BA-1347-9BB17C344E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5A6DE4-359C-AC98-D32E-E16D7AE23C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1520A0-EF9B-7630-5838-4A127B1AD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C96D51-CD48-703E-FE11-80B233169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E29524-FFCF-57FA-C879-0E9F08D90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038002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20E38-DCCF-DB0D-A4DE-D1906308A6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4E4720-6B1B-0ADE-7783-9D0AEB6D3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6AE206-5A0E-AF7C-CCBD-6B503F679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4369FE-0256-70A4-C33F-1C18B7BE7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177088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9B9B33-91B0-8DCE-174B-9C1FEC356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E5BD1F-FA56-55C9-0E3B-AE9F5A34B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BDB19-0973-6F50-7E20-831539E2A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322802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4AB03-B95B-4795-502E-B1F72C50C2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25AE39-D071-B3EC-CC23-C303B38C32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B97967-FFF8-5454-6BBC-829493EB18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5229A1-32A5-0606-29A4-4020ABC0F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2AB371-A781-D5B9-7861-0C86D1545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C4667C-8986-ECDA-3AE2-97F9A3617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41100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03B12-2856-D1C3-4A28-D00D430C6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E30940-8E95-C692-1DB0-17E8E46903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70B3BA-2434-C683-437C-6D5297A8E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DF2A5C-B269-7EDF-2AAE-F3CA80202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224E35-CFF3-3263-88B6-2643BC46E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9DBB79-3C5B-E0C4-2EE3-C0CDF3DF8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2474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BDFEF4-04B6-2B5A-C39E-DD7B7E1ED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AD6A8A-5748-EDCB-1427-9C28C8B9E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4DF6EE-5C9C-8337-C1AE-6523BEEC8A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974C4-C87E-49B5-BF75-A39A81F0B638}" type="datetimeFigureOut">
              <a:rPr lang="en-ID" smtClean="0"/>
              <a:t>04/12/2025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204FED-71E0-A183-C575-ECB1A97B4F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B8FD65-655D-AC2D-6C8A-82CC9617CA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851D56-B245-4EBA-93A3-D09BEEA4AC0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814271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sv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EAA09AE-867E-E483-244B-8155923CD2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7171" y="984927"/>
            <a:ext cx="2116322" cy="1570943"/>
          </a:xfrm>
          <a:prstGeom prst="rect">
            <a:avLst/>
          </a:prstGeom>
        </p:spPr>
      </p:pic>
      <p:sp>
        <p:nvSpPr>
          <p:cNvPr id="6" name="Arrow: Curved Right 5">
            <a:extLst>
              <a:ext uri="{FF2B5EF4-FFF2-40B4-BE49-F238E27FC236}">
                <a16:creationId xmlns:a16="http://schemas.microsoft.com/office/drawing/2014/main" id="{E0FE2725-8ACC-C06A-2787-487AA8BF58F4}"/>
              </a:ext>
            </a:extLst>
          </p:cNvPr>
          <p:cNvSpPr/>
          <p:nvPr/>
        </p:nvSpPr>
        <p:spPr>
          <a:xfrm>
            <a:off x="891888" y="1640367"/>
            <a:ext cx="911095" cy="2193500"/>
          </a:xfrm>
          <a:prstGeom prst="curvedRightArrow">
            <a:avLst>
              <a:gd name="adj1" fmla="val 25000"/>
              <a:gd name="adj2" fmla="val 51068"/>
              <a:gd name="adj3" fmla="val 7353"/>
            </a:avLst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D">
              <a:solidFill>
                <a:schemeClr val="tx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481BB8A-F8F4-8EC2-F483-C10DECDBF6EC}"/>
              </a:ext>
            </a:extLst>
          </p:cNvPr>
          <p:cNvSpPr txBox="1"/>
          <p:nvPr/>
        </p:nvSpPr>
        <p:spPr>
          <a:xfrm>
            <a:off x="1400839" y="2368127"/>
            <a:ext cx="6881923" cy="23688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ID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         ├─ Group 1 : Non-obese Control</a:t>
            </a:r>
            <a:endParaRPr lang="en-ID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         ├─ Group 2 : Obese Control</a:t>
            </a:r>
            <a:endParaRPr lang="en-ID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         ├─ Group 3 : Obese + Swimming Exercise </a:t>
            </a:r>
            <a:endParaRPr lang="en-ID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         ├─ Group 4 : Obese + Arabica Coffee </a:t>
            </a:r>
            <a:endParaRPr lang="en-ID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         └─ Group 5 : Obese + </a:t>
            </a:r>
            <a:r>
              <a:rPr lang="en-ID" kern="1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wimming </a:t>
            </a:r>
            <a:r>
              <a:rPr lang="en-ID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ID" kern="1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rabica Coffee</a:t>
            </a:r>
            <a:endParaRPr lang="en-ID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Arrow: Bent-Up 23">
            <a:extLst>
              <a:ext uri="{FF2B5EF4-FFF2-40B4-BE49-F238E27FC236}">
                <a16:creationId xmlns:a16="http://schemas.microsoft.com/office/drawing/2014/main" id="{7729E32C-060F-0365-0A69-047AC93A38CE}"/>
              </a:ext>
            </a:extLst>
          </p:cNvPr>
          <p:cNvSpPr/>
          <p:nvPr/>
        </p:nvSpPr>
        <p:spPr>
          <a:xfrm>
            <a:off x="6912832" y="2879935"/>
            <a:ext cx="2893497" cy="1570943"/>
          </a:xfrm>
          <a:prstGeom prst="bentUpArrow">
            <a:avLst>
              <a:gd name="adj1" fmla="val 25000"/>
              <a:gd name="adj2" fmla="val 24841"/>
              <a:gd name="adj3" fmla="val 39189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D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for 4 weeks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2FC3C87C-E765-C6C4-A6F5-7C5083D13F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3211" y="4957724"/>
            <a:ext cx="1481335" cy="1394466"/>
          </a:xfrm>
          <a:prstGeom prst="rect">
            <a:avLst/>
          </a:prstGeom>
        </p:spPr>
      </p:pic>
      <p:pic>
        <p:nvPicPr>
          <p:cNvPr id="38" name="Graphic 37" descr="Stopwatch">
            <a:extLst>
              <a:ext uri="{FF2B5EF4-FFF2-40B4-BE49-F238E27FC236}">
                <a16:creationId xmlns:a16="http://schemas.microsoft.com/office/drawing/2014/main" id="{376C7D1D-5CC4-3CAC-5C77-F6226AC92B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777834" y="3154443"/>
            <a:ext cx="914400" cy="914400"/>
          </a:xfrm>
          <a:prstGeom prst="rect">
            <a:avLst/>
          </a:prstGeom>
        </p:spPr>
      </p:pic>
      <p:pic>
        <p:nvPicPr>
          <p:cNvPr id="40" name="Graphic 39" descr="Arrow Slight curve">
            <a:extLst>
              <a:ext uri="{FF2B5EF4-FFF2-40B4-BE49-F238E27FC236}">
                <a16:creationId xmlns:a16="http://schemas.microsoft.com/office/drawing/2014/main" id="{60CABE77-5242-514A-EE99-E2E3B9A8CC4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 rot="1900586">
            <a:off x="2784190" y="4991861"/>
            <a:ext cx="1888810" cy="926136"/>
          </a:xfrm>
          <a:prstGeom prst="rect">
            <a:avLst/>
          </a:prstGeom>
        </p:spPr>
      </p:pic>
      <p:pic>
        <p:nvPicPr>
          <p:cNvPr id="42" name="Graphic 41" descr="Arrow Counterclockwise curve">
            <a:extLst>
              <a:ext uri="{FF2B5EF4-FFF2-40B4-BE49-F238E27FC236}">
                <a16:creationId xmlns:a16="http://schemas.microsoft.com/office/drawing/2014/main" id="{36E53258-C96A-89A9-9370-2A53FA5E2E6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rot="3460649">
            <a:off x="7176361" y="4365970"/>
            <a:ext cx="914400" cy="1563404"/>
          </a:xfrm>
          <a:prstGeom prst="rect">
            <a:avLst/>
          </a:prstGeom>
        </p:spPr>
      </p:pic>
      <p:pic>
        <p:nvPicPr>
          <p:cNvPr id="44" name="Graphic 43" descr="Tea">
            <a:extLst>
              <a:ext uri="{FF2B5EF4-FFF2-40B4-BE49-F238E27FC236}">
                <a16:creationId xmlns:a16="http://schemas.microsoft.com/office/drawing/2014/main" id="{AD7FED5B-F44E-B580-58B4-8BF93C5512E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5632106" y="3814570"/>
            <a:ext cx="620988" cy="620988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8326DACF-347A-034C-E271-6A526BA57FBE}"/>
              </a:ext>
            </a:extLst>
          </p:cNvPr>
          <p:cNvSpPr txBox="1"/>
          <p:nvPr/>
        </p:nvSpPr>
        <p:spPr>
          <a:xfrm>
            <a:off x="2594462" y="5908667"/>
            <a:ext cx="609777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D" sz="1200" b="1" dirty="0">
                <a:solidFill>
                  <a:schemeClr val="bg1">
                    <a:lumMod val="9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ecked before </a:t>
            </a:r>
          </a:p>
          <a:p>
            <a:pPr algn="ctr"/>
            <a:r>
              <a:rPr lang="en-ID" sz="1200" b="1" dirty="0">
                <a:solidFill>
                  <a:schemeClr val="bg1">
                    <a:lumMod val="9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after trial</a:t>
            </a:r>
          </a:p>
        </p:txBody>
      </p:sp>
      <p:sp>
        <p:nvSpPr>
          <p:cNvPr id="59" name="Cylinder 58">
            <a:extLst>
              <a:ext uri="{FF2B5EF4-FFF2-40B4-BE49-F238E27FC236}">
                <a16:creationId xmlns:a16="http://schemas.microsoft.com/office/drawing/2014/main" id="{C8E58778-115E-644B-712E-C96A94186926}"/>
              </a:ext>
            </a:extLst>
          </p:cNvPr>
          <p:cNvSpPr/>
          <p:nvPr/>
        </p:nvSpPr>
        <p:spPr>
          <a:xfrm>
            <a:off x="8599499" y="196800"/>
            <a:ext cx="1855326" cy="2575608"/>
          </a:xfrm>
          <a:prstGeom prst="can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180975" indent="-180975" algn="just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§"/>
            </a:pP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80975" indent="-180975" algn="just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§"/>
            </a:pP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L ↑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ly correlated with Lee Index</a:t>
            </a:r>
          </a:p>
          <a:p>
            <a:pPr marL="180975" indent="-180975" algn="just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§"/>
            </a:pP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, TG, LDL ↓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ly correlated with Lee Index</a:t>
            </a:r>
          </a:p>
          <a:p>
            <a:pPr marL="180975" indent="-180975" algn="just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§"/>
            </a:pP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st improvement: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ffee + Swimming</a:t>
            </a:r>
            <a:endParaRPr lang="en-ID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2768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3</TotalTime>
  <Words>79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USNI JOHAN</dc:creator>
  <cp:lastModifiedBy>YUSNI JOHAN</cp:lastModifiedBy>
  <cp:revision>22</cp:revision>
  <cp:lastPrinted>2025-06-28T05:41:08Z</cp:lastPrinted>
  <dcterms:created xsi:type="dcterms:W3CDTF">2025-06-18T03:26:15Z</dcterms:created>
  <dcterms:modified xsi:type="dcterms:W3CDTF">2025-12-04T15:52:24Z</dcterms:modified>
</cp:coreProperties>
</file>